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758" y="-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or ud Din Bin Sadiq" userId="c12ef6f6-bce1-458a-8e5c-679c74eefb5b" providerId="ADAL" clId="{7F7B81B4-1E13-4612-8D89-129F344B81E1}"/>
    <pc:docChg chg="undo custSel modSld">
      <pc:chgData name="Noor ud Din Bin Sadiq" userId="c12ef6f6-bce1-458a-8e5c-679c74eefb5b" providerId="ADAL" clId="{7F7B81B4-1E13-4612-8D89-129F344B81E1}" dt="2022-12-15T03:18:57.010" v="116" actId="1076"/>
      <pc:docMkLst>
        <pc:docMk/>
      </pc:docMkLst>
      <pc:sldChg chg="modSp mod">
        <pc:chgData name="Noor ud Din Bin Sadiq" userId="c12ef6f6-bce1-458a-8e5c-679c74eefb5b" providerId="ADAL" clId="{7F7B81B4-1E13-4612-8D89-129F344B81E1}" dt="2022-12-15T03:18:57.010" v="116" actId="1076"/>
        <pc:sldMkLst>
          <pc:docMk/>
          <pc:sldMk cId="4012540159" sldId="263"/>
        </pc:sldMkLst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11" creationId="{FACF1089-28E7-402B-A9D4-DCC4EC007D6D}"/>
          </ac:spMkLst>
        </pc:spChg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24" creationId="{61FC20E7-8C9A-4855-A569-7E5B51E80235}"/>
          </ac:spMkLst>
        </pc:spChg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27" creationId="{82D76B71-F98D-43CD-BD33-D4F87D4A6DE4}"/>
          </ac:spMkLst>
        </pc:spChg>
        <pc:spChg chg="mod">
          <ac:chgData name="Noor ud Din Bin Sadiq" userId="c12ef6f6-bce1-458a-8e5c-679c74eefb5b" providerId="ADAL" clId="{7F7B81B4-1E13-4612-8D89-129F344B81E1}" dt="2022-12-15T03:16:24.954" v="75" actId="1076"/>
          <ac:spMkLst>
            <pc:docMk/>
            <pc:sldMk cId="4012540159" sldId="263"/>
            <ac:spMk id="35" creationId="{82A1EFE1-6E70-4399-ABD8-B91E1A69C8B4}"/>
          </ac:spMkLst>
        </pc:spChg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36" creationId="{8AD60DFA-9CB7-4DD9-8375-61D835E70D38}"/>
          </ac:spMkLst>
        </pc:spChg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37" creationId="{D2ED7E56-2EE3-4F9C-B87E-C70BA94D0A53}"/>
          </ac:spMkLst>
        </pc:spChg>
        <pc:spChg chg="mod">
          <ac:chgData name="Noor ud Din Bin Sadiq" userId="c12ef6f6-bce1-458a-8e5c-679c74eefb5b" providerId="ADAL" clId="{7F7B81B4-1E13-4612-8D89-129F344B81E1}" dt="2022-12-15T03:16:05.060" v="3" actId="1076"/>
          <ac:spMkLst>
            <pc:docMk/>
            <pc:sldMk cId="4012540159" sldId="263"/>
            <ac:spMk id="38" creationId="{0EC0B08D-38AD-4AD3-8E86-8C0763975380}"/>
          </ac:spMkLst>
        </pc:spChg>
        <pc:spChg chg="mod">
          <ac:chgData name="Noor ud Din Bin Sadiq" userId="c12ef6f6-bce1-458a-8e5c-679c74eefb5b" providerId="ADAL" clId="{7F7B81B4-1E13-4612-8D89-129F344B81E1}" dt="2022-12-15T03:17:23.629" v="78" actId="1076"/>
          <ac:spMkLst>
            <pc:docMk/>
            <pc:sldMk cId="4012540159" sldId="263"/>
            <ac:spMk id="47" creationId="{0638FEC4-C124-4F53-B037-8ED88A49E4F0}"/>
          </ac:spMkLst>
        </pc:spChg>
        <pc:spChg chg="mod">
          <ac:chgData name="Noor ud Din Bin Sadiq" userId="c12ef6f6-bce1-458a-8e5c-679c74eefb5b" providerId="ADAL" clId="{7F7B81B4-1E13-4612-8D89-129F344B81E1}" dt="2022-12-15T03:18:22.461" v="111" actId="1036"/>
          <ac:spMkLst>
            <pc:docMk/>
            <pc:sldMk cId="4012540159" sldId="263"/>
            <ac:spMk id="59" creationId="{EF07915C-69C4-45F0-B539-8D3E3DE51991}"/>
          </ac:spMkLst>
        </pc:spChg>
        <pc:spChg chg="mod">
          <ac:chgData name="Noor ud Din Bin Sadiq" userId="c12ef6f6-bce1-458a-8e5c-679c74eefb5b" providerId="ADAL" clId="{7F7B81B4-1E13-4612-8D89-129F344B81E1}" dt="2022-12-15T03:18:22.461" v="111" actId="1036"/>
          <ac:spMkLst>
            <pc:docMk/>
            <pc:sldMk cId="4012540159" sldId="263"/>
            <ac:spMk id="60" creationId="{7DBEED61-4283-4B82-A08C-5B9C2009778E}"/>
          </ac:spMkLst>
        </pc:spChg>
        <pc:spChg chg="mod">
          <ac:chgData name="Noor ud Din Bin Sadiq" userId="c12ef6f6-bce1-458a-8e5c-679c74eefb5b" providerId="ADAL" clId="{7F7B81B4-1E13-4612-8D89-129F344B81E1}" dt="2022-12-15T03:18:22.461" v="111" actId="1036"/>
          <ac:spMkLst>
            <pc:docMk/>
            <pc:sldMk cId="4012540159" sldId="263"/>
            <ac:spMk id="61" creationId="{99CEF14D-F55C-4208-86D1-CF9A9B1924DF}"/>
          </ac:spMkLst>
        </pc:spChg>
        <pc:spChg chg="mod">
          <ac:chgData name="Noor ud Din Bin Sadiq" userId="c12ef6f6-bce1-458a-8e5c-679c74eefb5b" providerId="ADAL" clId="{7F7B81B4-1E13-4612-8D89-129F344B81E1}" dt="2022-12-15T03:18:22.461" v="111" actId="1036"/>
          <ac:spMkLst>
            <pc:docMk/>
            <pc:sldMk cId="4012540159" sldId="263"/>
            <ac:spMk id="62" creationId="{9389A567-D9C0-4642-8099-DDAA8CA00DB4}"/>
          </ac:spMkLst>
        </pc:spChg>
        <pc:spChg chg="mod">
          <ac:chgData name="Noor ud Din Bin Sadiq" userId="c12ef6f6-bce1-458a-8e5c-679c74eefb5b" providerId="ADAL" clId="{7F7B81B4-1E13-4612-8D89-129F344B81E1}" dt="2022-12-15T03:18:48.874" v="115" actId="1076"/>
          <ac:spMkLst>
            <pc:docMk/>
            <pc:sldMk cId="4012540159" sldId="263"/>
            <ac:spMk id="68" creationId="{427D9E16-1163-4983-AD1A-A769B620B2B7}"/>
          </ac:spMkLst>
        </pc:spChg>
        <pc:grpChg chg="mod">
          <ac:chgData name="Noor ud Din Bin Sadiq" userId="c12ef6f6-bce1-458a-8e5c-679c74eefb5b" providerId="ADAL" clId="{7F7B81B4-1E13-4612-8D89-129F344B81E1}" dt="2022-12-15T03:18:57.010" v="116" actId="1076"/>
          <ac:grpSpMkLst>
            <pc:docMk/>
            <pc:sldMk cId="4012540159" sldId="263"/>
            <ac:grpSpMk id="2" creationId="{BED00BA1-BDE9-428E-93A2-2CCAA92E36CA}"/>
          </ac:grpSpMkLst>
        </pc:grpChg>
        <pc:picChg chg="mod">
          <ac:chgData name="Noor ud Din Bin Sadiq" userId="c12ef6f6-bce1-458a-8e5c-679c74eefb5b" providerId="ADAL" clId="{7F7B81B4-1E13-4612-8D89-129F344B81E1}" dt="2022-12-15T03:16:05.060" v="3" actId="1076"/>
          <ac:picMkLst>
            <pc:docMk/>
            <pc:sldMk cId="4012540159" sldId="263"/>
            <ac:picMk id="42" creationId="{E1996C65-9142-4173-849C-E09F56212CC4}"/>
          </ac:picMkLst>
        </pc:picChg>
        <pc:picChg chg="mod">
          <ac:chgData name="Noor ud Din Bin Sadiq" userId="c12ef6f6-bce1-458a-8e5c-679c74eefb5b" providerId="ADAL" clId="{7F7B81B4-1E13-4612-8D89-129F344B81E1}" dt="2022-12-15T03:17:43.026" v="80" actId="1076"/>
          <ac:picMkLst>
            <pc:docMk/>
            <pc:sldMk cId="4012540159" sldId="263"/>
            <ac:picMk id="70" creationId="{3BC1D086-33D0-4FAE-AFEA-232B770101D4}"/>
          </ac:picMkLst>
        </pc:picChg>
        <pc:cxnChg chg="mod">
          <ac:chgData name="Noor ud Din Bin Sadiq" userId="c12ef6f6-bce1-458a-8e5c-679c74eefb5b" providerId="ADAL" clId="{7F7B81B4-1E13-4612-8D89-129F344B81E1}" dt="2022-12-15T03:16:15.188" v="74" actId="1037"/>
          <ac:cxnSpMkLst>
            <pc:docMk/>
            <pc:sldMk cId="4012540159" sldId="263"/>
            <ac:cxnSpMk id="29" creationId="{166AF767-3EAE-41E0-BCDC-12A276FD3AD8}"/>
          </ac:cxnSpMkLst>
        </pc:cxnChg>
        <pc:cxnChg chg="mod">
          <ac:chgData name="Noor ud Din Bin Sadiq" userId="c12ef6f6-bce1-458a-8e5c-679c74eefb5b" providerId="ADAL" clId="{7F7B81B4-1E13-4612-8D89-129F344B81E1}" dt="2022-12-15T03:16:05.060" v="3" actId="1076"/>
          <ac:cxnSpMkLst>
            <pc:docMk/>
            <pc:sldMk cId="4012540159" sldId="263"/>
            <ac:cxnSpMk id="40" creationId="{40141CA4-383F-4354-BB7D-072E452C205C}"/>
          </ac:cxnSpMkLst>
        </pc:cxnChg>
        <pc:cxnChg chg="mod">
          <ac:chgData name="Noor ud Din Bin Sadiq" userId="c12ef6f6-bce1-458a-8e5c-679c74eefb5b" providerId="ADAL" clId="{7F7B81B4-1E13-4612-8D89-129F344B81E1}" dt="2022-12-15T03:17:56.524" v="86" actId="1037"/>
          <ac:cxnSpMkLst>
            <pc:docMk/>
            <pc:sldMk cId="4012540159" sldId="263"/>
            <ac:cxnSpMk id="50" creationId="{77E3CD29-CF57-4CFF-A0F6-4E413E0884B8}"/>
          </ac:cxnSpMkLst>
        </pc:cxnChg>
        <pc:cxnChg chg="mod">
          <ac:chgData name="Noor ud Din Bin Sadiq" userId="c12ef6f6-bce1-458a-8e5c-679c74eefb5b" providerId="ADAL" clId="{7F7B81B4-1E13-4612-8D89-129F344B81E1}" dt="2022-12-15T03:18:42.282" v="114" actId="1076"/>
          <ac:cxnSpMkLst>
            <pc:docMk/>
            <pc:sldMk cId="4012540159" sldId="263"/>
            <ac:cxnSpMk id="67" creationId="{AD78F573-EFE5-4A8E-BE52-5DE4E7BE5C36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817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959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371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710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90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828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017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846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211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976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386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7FDA6-5988-4A4C-B421-E8EB2E412BF0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6E23A-C090-447C-8C80-7969A86E7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968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ED00BA1-BDE9-428E-93A2-2CCAA92E36CA}"/>
              </a:ext>
            </a:extLst>
          </p:cNvPr>
          <p:cNvGrpSpPr/>
          <p:nvPr/>
        </p:nvGrpSpPr>
        <p:grpSpPr>
          <a:xfrm>
            <a:off x="1470357" y="1581402"/>
            <a:ext cx="3917285" cy="4641504"/>
            <a:chOff x="0" y="0"/>
            <a:chExt cx="4243861" cy="5028472"/>
          </a:xfrm>
        </p:grpSpPr>
        <p:sp>
          <p:nvSpPr>
            <p:cNvPr id="3" name="Text Box 2">
              <a:extLst>
                <a:ext uri="{FF2B5EF4-FFF2-40B4-BE49-F238E27FC236}">
                  <a16:creationId xmlns:a16="http://schemas.microsoft.com/office/drawing/2014/main" id="{1CF59A51-6EE7-43AB-B7AD-C7512A3E62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0"/>
              <a:ext cx="733579" cy="2266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ot="0" vert="horz" wrap="square" lIns="84407" tIns="42203" rIns="84407" bIns="42203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740"/>
                </a:spcAft>
              </a:pPr>
              <a:r>
                <a:rPr lang="en-GB" sz="1108" b="1" dirty="0">
                  <a:latin typeface="Times New Roman" panose="02020603050405020304" pitchFamily="18" charset="0"/>
                  <a:ea typeface="Malgun Gothic" panose="020B0503020000020004" pitchFamily="34" charset="-127"/>
                  <a:cs typeface="Arial" panose="020B0604020202020204" pitchFamily="34" charset="0"/>
                </a:rPr>
                <a:t>Fig. S1</a:t>
              </a:r>
              <a:endParaRPr lang="en-US" sz="1017" dirty="0"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7193B76-6C0F-4EFD-9CD6-F5D00E5445FE}"/>
                </a:ext>
              </a:extLst>
            </p:cNvPr>
            <p:cNvGrpSpPr/>
            <p:nvPr/>
          </p:nvGrpSpPr>
          <p:grpSpPr>
            <a:xfrm>
              <a:off x="304800" y="296562"/>
              <a:ext cx="3939061" cy="4731910"/>
              <a:chOff x="0" y="0"/>
              <a:chExt cx="3590528" cy="4178414"/>
            </a:xfrm>
          </p:grpSpPr>
          <p:pic>
            <p:nvPicPr>
              <p:cNvPr id="43" name="그림 7">
                <a:extLst>
                  <a:ext uri="{FF2B5EF4-FFF2-40B4-BE49-F238E27FC236}">
                    <a16:creationId xmlns:a16="http://schemas.microsoft.com/office/drawing/2014/main" id="{A2D02571-46C4-4E55-88D9-87A9A3A744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79647"/>
              <a:stretch/>
            </p:blipFill>
            <p:spPr>
              <a:xfrm>
                <a:off x="0" y="421169"/>
                <a:ext cx="1743683" cy="1295025"/>
              </a:xfrm>
              <a:prstGeom prst="rect">
                <a:avLst/>
              </a:prstGeom>
            </p:spPr>
          </p:pic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8FB3C541-43EB-40C0-B872-4F7091CBF668}"/>
                  </a:ext>
                </a:extLst>
              </p:cNvPr>
              <p:cNvGrpSpPr/>
              <p:nvPr/>
            </p:nvGrpSpPr>
            <p:grpSpPr>
              <a:xfrm>
                <a:off x="60676" y="0"/>
                <a:ext cx="3529852" cy="4178414"/>
                <a:chOff x="60676" y="0"/>
                <a:chExt cx="3529852" cy="4178414"/>
              </a:xfrm>
            </p:grpSpPr>
            <p:sp>
              <p:nvSpPr>
                <p:cNvPr id="45" name="TextBox 8">
                  <a:extLst>
                    <a:ext uri="{FF2B5EF4-FFF2-40B4-BE49-F238E27FC236}">
                      <a16:creationId xmlns:a16="http://schemas.microsoft.com/office/drawing/2014/main" id="{A3121D75-4761-4B23-BA2C-F684C801D97E}"/>
                    </a:ext>
                  </a:extLst>
                </p:cNvPr>
                <p:cNvSpPr txBox="1"/>
                <p:nvPr/>
              </p:nvSpPr>
              <p:spPr>
                <a:xfrm>
                  <a:off x="60676" y="0"/>
                  <a:ext cx="1778000" cy="6413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AGS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(stomach cancer)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9">
                  <a:extLst>
                    <a:ext uri="{FF2B5EF4-FFF2-40B4-BE49-F238E27FC236}">
                      <a16:creationId xmlns:a16="http://schemas.microsoft.com/office/drawing/2014/main" id="{F9C63BFC-1FF7-4BAA-95D2-88B8989183B4}"/>
                    </a:ext>
                  </a:extLst>
                </p:cNvPr>
                <p:cNvSpPr txBox="1"/>
                <p:nvPr/>
              </p:nvSpPr>
              <p:spPr>
                <a:xfrm>
                  <a:off x="1748429" y="0"/>
                  <a:ext cx="1778635" cy="6413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HCT116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(colon cancer)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10">
                  <a:extLst>
                    <a:ext uri="{FF2B5EF4-FFF2-40B4-BE49-F238E27FC236}">
                      <a16:creationId xmlns:a16="http://schemas.microsoft.com/office/drawing/2014/main" id="{0638FEC4-C124-4F53-B037-8ED88A49E4F0}"/>
                    </a:ext>
                  </a:extLst>
                </p:cNvPr>
                <p:cNvSpPr txBox="1"/>
                <p:nvPr/>
              </p:nvSpPr>
              <p:spPr>
                <a:xfrm>
                  <a:off x="1811893" y="2163128"/>
                  <a:ext cx="1778635" cy="6413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A549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(lung cancer)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8" name="직선 연결선 13">
                  <a:extLst>
                    <a:ext uri="{FF2B5EF4-FFF2-40B4-BE49-F238E27FC236}">
                      <a16:creationId xmlns:a16="http://schemas.microsoft.com/office/drawing/2014/main" id="{A0DB7A0C-2A58-4D11-B7A2-FDE294A299CD}"/>
                    </a:ext>
                  </a:extLst>
                </p:cNvPr>
                <p:cNvCxnSpPr/>
                <p:nvPr/>
              </p:nvCxnSpPr>
              <p:spPr>
                <a:xfrm>
                  <a:off x="305652" y="850680"/>
                  <a:ext cx="1296000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직선 연결선 14">
                  <a:extLst>
                    <a:ext uri="{FF2B5EF4-FFF2-40B4-BE49-F238E27FC236}">
                      <a16:creationId xmlns:a16="http://schemas.microsoft.com/office/drawing/2014/main" id="{533EDCE1-3E2B-4185-A878-F1730A02CA50}"/>
                    </a:ext>
                  </a:extLst>
                </p:cNvPr>
                <p:cNvCxnSpPr/>
                <p:nvPr/>
              </p:nvCxnSpPr>
              <p:spPr>
                <a:xfrm>
                  <a:off x="2004277" y="844330"/>
                  <a:ext cx="1296000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직선 연결선 15">
                  <a:extLst>
                    <a:ext uri="{FF2B5EF4-FFF2-40B4-BE49-F238E27FC236}">
                      <a16:creationId xmlns:a16="http://schemas.microsoft.com/office/drawing/2014/main" id="{77E3CD29-CF57-4CFF-A0F6-4E413E0884B8}"/>
                    </a:ext>
                  </a:extLst>
                </p:cNvPr>
                <p:cNvCxnSpPr/>
                <p:nvPr/>
              </p:nvCxnSpPr>
              <p:spPr>
                <a:xfrm>
                  <a:off x="2137184" y="2956895"/>
                  <a:ext cx="1296000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20">
                  <a:extLst>
                    <a:ext uri="{FF2B5EF4-FFF2-40B4-BE49-F238E27FC236}">
                      <a16:creationId xmlns:a16="http://schemas.microsoft.com/office/drawing/2014/main" id="{51FDB29E-FB4C-457D-B046-366622E43A08}"/>
                    </a:ext>
                  </a:extLst>
                </p:cNvPr>
                <p:cNvSpPr txBox="1"/>
                <p:nvPr/>
              </p:nvSpPr>
              <p:spPr>
                <a:xfrm rot="18900000">
                  <a:off x="301525" y="1514484"/>
                  <a:ext cx="32512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C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TextBox 21">
                  <a:extLst>
                    <a:ext uri="{FF2B5EF4-FFF2-40B4-BE49-F238E27FC236}">
                      <a16:creationId xmlns:a16="http://schemas.microsoft.com/office/drawing/2014/main" id="{3ECFB8D7-0ABE-4DC6-B388-4C878B7F0CAB}"/>
                    </a:ext>
                  </a:extLst>
                </p:cNvPr>
                <p:cNvSpPr txBox="1"/>
                <p:nvPr/>
              </p:nvSpPr>
              <p:spPr>
                <a:xfrm rot="18900000">
                  <a:off x="551442" y="1514484"/>
                  <a:ext cx="479425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Light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TextBox 22">
                  <a:extLst>
                    <a:ext uri="{FF2B5EF4-FFF2-40B4-BE49-F238E27FC236}">
                      <a16:creationId xmlns:a16="http://schemas.microsoft.com/office/drawing/2014/main" id="{4F26402B-B185-44D1-B427-60FBE66E4753}"/>
                    </a:ext>
                  </a:extLst>
                </p:cNvPr>
                <p:cNvSpPr txBox="1"/>
                <p:nvPr/>
              </p:nvSpPr>
              <p:spPr>
                <a:xfrm rot="18900000">
                  <a:off x="899834" y="1514484"/>
                  <a:ext cx="46482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Blue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TextBox 23">
                  <a:extLst>
                    <a:ext uri="{FF2B5EF4-FFF2-40B4-BE49-F238E27FC236}">
                      <a16:creationId xmlns:a16="http://schemas.microsoft.com/office/drawing/2014/main" id="{ADE7EC48-6EF6-4613-A8F1-008E6B9648BD}"/>
                    </a:ext>
                  </a:extLst>
                </p:cNvPr>
                <p:cNvSpPr txBox="1"/>
                <p:nvPr/>
              </p:nvSpPr>
              <p:spPr>
                <a:xfrm rot="18900000">
                  <a:off x="1227821" y="1514484"/>
                  <a:ext cx="459105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Dark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TextBox 24">
                  <a:extLst>
                    <a:ext uri="{FF2B5EF4-FFF2-40B4-BE49-F238E27FC236}">
                      <a16:creationId xmlns:a16="http://schemas.microsoft.com/office/drawing/2014/main" id="{7AE7CFE2-1D5A-43C4-9B51-4A334D1B261F}"/>
                    </a:ext>
                  </a:extLst>
                </p:cNvPr>
                <p:cNvSpPr txBox="1"/>
                <p:nvPr/>
              </p:nvSpPr>
              <p:spPr>
                <a:xfrm rot="18900000">
                  <a:off x="2000492" y="1514484"/>
                  <a:ext cx="32512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C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Box 25">
                  <a:extLst>
                    <a:ext uri="{FF2B5EF4-FFF2-40B4-BE49-F238E27FC236}">
                      <a16:creationId xmlns:a16="http://schemas.microsoft.com/office/drawing/2014/main" id="{36856DC4-486A-4955-9BA3-3DA66B27832E}"/>
                    </a:ext>
                  </a:extLst>
                </p:cNvPr>
                <p:cNvSpPr txBox="1"/>
                <p:nvPr/>
              </p:nvSpPr>
              <p:spPr>
                <a:xfrm rot="18900000">
                  <a:off x="2250409" y="1514484"/>
                  <a:ext cx="47879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Light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26">
                  <a:extLst>
                    <a:ext uri="{FF2B5EF4-FFF2-40B4-BE49-F238E27FC236}">
                      <a16:creationId xmlns:a16="http://schemas.microsoft.com/office/drawing/2014/main" id="{663E7340-9D9E-41DD-BCC3-1A5491A74ADE}"/>
                    </a:ext>
                  </a:extLst>
                </p:cNvPr>
                <p:cNvSpPr txBox="1"/>
                <p:nvPr/>
              </p:nvSpPr>
              <p:spPr>
                <a:xfrm rot="18900000">
                  <a:off x="2598801" y="1514484"/>
                  <a:ext cx="464185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Blue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27">
                  <a:extLst>
                    <a:ext uri="{FF2B5EF4-FFF2-40B4-BE49-F238E27FC236}">
                      <a16:creationId xmlns:a16="http://schemas.microsoft.com/office/drawing/2014/main" id="{00140A1E-D801-48DE-9929-6F0C85E11AC4}"/>
                    </a:ext>
                  </a:extLst>
                </p:cNvPr>
                <p:cNvSpPr txBox="1"/>
                <p:nvPr/>
              </p:nvSpPr>
              <p:spPr>
                <a:xfrm rot="18900000">
                  <a:off x="2926788" y="1514484"/>
                  <a:ext cx="45974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Dark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TextBox 28">
                  <a:extLst>
                    <a:ext uri="{FF2B5EF4-FFF2-40B4-BE49-F238E27FC236}">
                      <a16:creationId xmlns:a16="http://schemas.microsoft.com/office/drawing/2014/main" id="{EF07915C-69C4-45F0-B539-8D3E3DE51991}"/>
                    </a:ext>
                  </a:extLst>
                </p:cNvPr>
                <p:cNvSpPr txBox="1"/>
                <p:nvPr/>
              </p:nvSpPr>
              <p:spPr>
                <a:xfrm rot="18900000">
                  <a:off x="2030961" y="3502658"/>
                  <a:ext cx="32512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C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TextBox 29">
                  <a:extLst>
                    <a:ext uri="{FF2B5EF4-FFF2-40B4-BE49-F238E27FC236}">
                      <a16:creationId xmlns:a16="http://schemas.microsoft.com/office/drawing/2014/main" id="{7DBEED61-4283-4B82-A08C-5B9C2009778E}"/>
                    </a:ext>
                  </a:extLst>
                </p:cNvPr>
                <p:cNvSpPr txBox="1"/>
                <p:nvPr/>
              </p:nvSpPr>
              <p:spPr>
                <a:xfrm rot="18900000">
                  <a:off x="2280877" y="3502658"/>
                  <a:ext cx="47879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Light</a:t>
                  </a:r>
                  <a:endParaRPr lang="en-US" sz="1017" dirty="0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TextBox 30">
                  <a:extLst>
                    <a:ext uri="{FF2B5EF4-FFF2-40B4-BE49-F238E27FC236}">
                      <a16:creationId xmlns:a16="http://schemas.microsoft.com/office/drawing/2014/main" id="{99CEF14D-F55C-4208-86D1-CF9A9B1924DF}"/>
                    </a:ext>
                  </a:extLst>
                </p:cNvPr>
                <p:cNvSpPr txBox="1"/>
                <p:nvPr/>
              </p:nvSpPr>
              <p:spPr>
                <a:xfrm rot="18900000">
                  <a:off x="2629269" y="3502662"/>
                  <a:ext cx="464185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Blue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TextBox 31">
                  <a:extLst>
                    <a:ext uri="{FF2B5EF4-FFF2-40B4-BE49-F238E27FC236}">
                      <a16:creationId xmlns:a16="http://schemas.microsoft.com/office/drawing/2014/main" id="{9389A567-D9C0-4642-8099-DDAA8CA00DB4}"/>
                    </a:ext>
                  </a:extLst>
                </p:cNvPr>
                <p:cNvSpPr txBox="1"/>
                <p:nvPr/>
              </p:nvSpPr>
              <p:spPr>
                <a:xfrm rot="18900000">
                  <a:off x="2957256" y="3502658"/>
                  <a:ext cx="459740" cy="3346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Dark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3" name="직선 연결선 41">
                  <a:extLst>
                    <a:ext uri="{FF2B5EF4-FFF2-40B4-BE49-F238E27FC236}">
                      <a16:creationId xmlns:a16="http://schemas.microsoft.com/office/drawing/2014/main" id="{9AB51E68-4792-4C96-AEBA-96352F2FD760}"/>
                    </a:ext>
                  </a:extLst>
                </p:cNvPr>
                <p:cNvCxnSpPr/>
                <p:nvPr/>
              </p:nvCxnSpPr>
              <p:spPr>
                <a:xfrm>
                  <a:off x="695611" y="1854527"/>
                  <a:ext cx="86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Box 42">
                  <a:extLst>
                    <a:ext uri="{FF2B5EF4-FFF2-40B4-BE49-F238E27FC236}">
                      <a16:creationId xmlns:a16="http://schemas.microsoft.com/office/drawing/2014/main" id="{A8CE8D9B-2649-47E6-8B02-5401D542EE82}"/>
                    </a:ext>
                  </a:extLst>
                </p:cNvPr>
                <p:cNvSpPr txBox="1"/>
                <p:nvPr/>
              </p:nvSpPr>
              <p:spPr>
                <a:xfrm>
                  <a:off x="691536" y="1899735"/>
                  <a:ext cx="871855" cy="3600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 100 </a:t>
                  </a:r>
                  <a:r>
                    <a:rPr lang="el-GR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μ</a:t>
                  </a: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g/ml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5" name="직선 연결선 43">
                  <a:extLst>
                    <a:ext uri="{FF2B5EF4-FFF2-40B4-BE49-F238E27FC236}">
                      <a16:creationId xmlns:a16="http://schemas.microsoft.com/office/drawing/2014/main" id="{023EC865-92D4-48C7-8D53-71330138B280}"/>
                    </a:ext>
                  </a:extLst>
                </p:cNvPr>
                <p:cNvCxnSpPr/>
                <p:nvPr/>
              </p:nvCxnSpPr>
              <p:spPr>
                <a:xfrm>
                  <a:off x="2390972" y="1855558"/>
                  <a:ext cx="86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TextBox 44">
                  <a:extLst>
                    <a:ext uri="{FF2B5EF4-FFF2-40B4-BE49-F238E27FC236}">
                      <a16:creationId xmlns:a16="http://schemas.microsoft.com/office/drawing/2014/main" id="{6C873AEF-6AEC-457A-9E4B-10C3EF8953B6}"/>
                    </a:ext>
                  </a:extLst>
                </p:cNvPr>
                <p:cNvSpPr txBox="1"/>
                <p:nvPr/>
              </p:nvSpPr>
              <p:spPr>
                <a:xfrm>
                  <a:off x="2386811" y="1900789"/>
                  <a:ext cx="871855" cy="3600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 100 </a:t>
                  </a:r>
                  <a:r>
                    <a:rPr lang="el-GR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μ</a:t>
                  </a: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g/ml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7" name="직선 연결선 45">
                  <a:extLst>
                    <a:ext uri="{FF2B5EF4-FFF2-40B4-BE49-F238E27FC236}">
                      <a16:creationId xmlns:a16="http://schemas.microsoft.com/office/drawing/2014/main" id="{AD78F573-EFE5-4A8E-BE52-5DE4E7BE5C36}"/>
                    </a:ext>
                  </a:extLst>
                </p:cNvPr>
                <p:cNvCxnSpPr/>
                <p:nvPr/>
              </p:nvCxnSpPr>
              <p:spPr>
                <a:xfrm>
                  <a:off x="2429361" y="3793656"/>
                  <a:ext cx="86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46">
                  <a:extLst>
                    <a:ext uri="{FF2B5EF4-FFF2-40B4-BE49-F238E27FC236}">
                      <a16:creationId xmlns:a16="http://schemas.microsoft.com/office/drawing/2014/main" id="{427D9E16-1163-4983-AD1A-A769B620B2B7}"/>
                    </a:ext>
                  </a:extLst>
                </p:cNvPr>
                <p:cNvSpPr txBox="1"/>
                <p:nvPr/>
              </p:nvSpPr>
              <p:spPr>
                <a:xfrm>
                  <a:off x="2318476" y="3818369"/>
                  <a:ext cx="871855" cy="3600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 algn="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 100 </a:t>
                  </a:r>
                  <a:r>
                    <a:rPr lang="el-GR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μ</a:t>
                  </a:r>
                  <a:r>
                    <a:rPr lang="en-US" sz="923">
                      <a:solidFill>
                        <a:srgbClr val="000000"/>
                      </a:solidFill>
                      <a:latin typeface="Calibri" panose="020F050202020403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g/ml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9" name="그림 7">
                  <a:extLst>
                    <a:ext uri="{FF2B5EF4-FFF2-40B4-BE49-F238E27FC236}">
                      <a16:creationId xmlns:a16="http://schemas.microsoft.com/office/drawing/2014/main" id="{BAEA2AE0-1A13-43E6-BCC1-6D3EEB42E8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0402" r="59993"/>
                <a:stretch/>
              </p:blipFill>
              <p:spPr>
                <a:xfrm>
                  <a:off x="1729198" y="413146"/>
                  <a:ext cx="1679588" cy="1295025"/>
                </a:xfrm>
                <a:prstGeom prst="rect">
                  <a:avLst/>
                </a:prstGeom>
              </p:spPr>
            </p:pic>
            <p:pic>
              <p:nvPicPr>
                <p:cNvPr id="70" name="그림 7">
                  <a:extLst>
                    <a:ext uri="{FF2B5EF4-FFF2-40B4-BE49-F238E27FC236}">
                      <a16:creationId xmlns:a16="http://schemas.microsoft.com/office/drawing/2014/main" id="{3BC1D086-33D0-4FAE-AFEA-232B770101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39943" r="40189"/>
                <a:stretch/>
              </p:blipFill>
              <p:spPr>
                <a:xfrm>
                  <a:off x="1893395" y="2578899"/>
                  <a:ext cx="1497057" cy="1139015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E5574EE8-6596-44FF-8CB7-A39EA16B5C6C}"/>
                </a:ext>
              </a:extLst>
            </p:cNvPr>
            <p:cNvGrpSpPr/>
            <p:nvPr/>
          </p:nvGrpSpPr>
          <p:grpSpPr>
            <a:xfrm>
              <a:off x="468620" y="2746233"/>
              <a:ext cx="1747085" cy="2160002"/>
              <a:chOff x="-198645" y="-5205"/>
              <a:chExt cx="1747085" cy="2160002"/>
            </a:xfrm>
          </p:grpSpPr>
          <p:sp>
            <p:nvSpPr>
              <p:cNvPr id="24" name="TextBox 50">
                <a:extLst>
                  <a:ext uri="{FF2B5EF4-FFF2-40B4-BE49-F238E27FC236}">
                    <a16:creationId xmlns:a16="http://schemas.microsoft.com/office/drawing/2014/main" id="{61FC20E7-8C9A-4855-A569-7E5B51E80235}"/>
                  </a:ext>
                </a:extLst>
              </p:cNvPr>
              <p:cNvSpPr txBox="1"/>
              <p:nvPr/>
            </p:nvSpPr>
            <p:spPr>
              <a:xfrm>
                <a:off x="488302" y="1897425"/>
                <a:ext cx="871854" cy="2573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latinLnBrk="1">
                  <a:lnSpc>
                    <a:spcPct val="107000"/>
                  </a:lnSpc>
                  <a:spcAft>
                    <a:spcPts val="740"/>
                  </a:spcAft>
                </a:pPr>
                <a:r>
                  <a:rPr lang="en-US" sz="923">
                    <a:solidFill>
                      <a:srgbClr val="000000"/>
                    </a:solidFill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 100 </a:t>
                </a:r>
                <a:r>
                  <a:rPr lang="el-GR" sz="923">
                    <a:solidFill>
                      <a:srgbClr val="000000"/>
                    </a:solidFill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μ</a:t>
                </a:r>
                <a:r>
                  <a:rPr lang="en-US" sz="923">
                    <a:solidFill>
                      <a:srgbClr val="000000"/>
                    </a:solidFill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rPr>
                  <a:t>g/ml</a:t>
                </a:r>
                <a:endParaRPr lang="en-US" sz="1017">
                  <a:latin typeface="Calibri" panose="020F0502020204030204" pitchFamily="34" charset="0"/>
                  <a:ea typeface="Malgun Gothic" panose="020B0503020000020004" pitchFamily="34" charset="-127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6C23B3F6-9B33-446B-8AE1-62D2B6B8A068}"/>
                  </a:ext>
                </a:extLst>
              </p:cNvPr>
              <p:cNvGrpSpPr/>
              <p:nvPr/>
            </p:nvGrpSpPr>
            <p:grpSpPr>
              <a:xfrm>
                <a:off x="-198645" y="-5205"/>
                <a:ext cx="1747085" cy="1857281"/>
                <a:chOff x="-198645" y="-5205"/>
                <a:chExt cx="1747085" cy="1857281"/>
              </a:xfrm>
            </p:grpSpPr>
            <p:sp>
              <p:nvSpPr>
                <p:cNvPr id="27" name="TextBox 12">
                  <a:extLst>
                    <a:ext uri="{FF2B5EF4-FFF2-40B4-BE49-F238E27FC236}">
                      <a16:creationId xmlns:a16="http://schemas.microsoft.com/office/drawing/2014/main" id="{82D76B71-F98D-43CD-BD33-D4F87D4A6DE4}"/>
                    </a:ext>
                  </a:extLst>
                </p:cNvPr>
                <p:cNvSpPr txBox="1"/>
                <p:nvPr/>
              </p:nvSpPr>
              <p:spPr>
                <a:xfrm>
                  <a:off x="-54302" y="-5205"/>
                  <a:ext cx="1602742" cy="5510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Huh-7</a:t>
                  </a:r>
                  <a:endParaRPr lang="en-US" sz="1017" dirty="0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1017" u="sng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(liver cancer)</a:t>
                  </a:r>
                  <a:endParaRPr lang="en-US" sz="1017" dirty="0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" name="직선 연결선 17">
                  <a:extLst>
                    <a:ext uri="{FF2B5EF4-FFF2-40B4-BE49-F238E27FC236}">
                      <a16:creationId xmlns:a16="http://schemas.microsoft.com/office/drawing/2014/main" id="{166AF767-3EAE-41E0-BCDC-12A276FD3AD8}"/>
                    </a:ext>
                  </a:extLst>
                </p:cNvPr>
                <p:cNvCxnSpPr/>
                <p:nvPr/>
              </p:nvCxnSpPr>
              <p:spPr>
                <a:xfrm>
                  <a:off x="95589" y="850681"/>
                  <a:ext cx="1296002" cy="0"/>
                </a:xfrm>
                <a:prstGeom prst="line">
                  <a:avLst/>
                </a:prstGeom>
                <a:ln w="12700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6">
                  <a:extLst>
                    <a:ext uri="{FF2B5EF4-FFF2-40B4-BE49-F238E27FC236}">
                      <a16:creationId xmlns:a16="http://schemas.microsoft.com/office/drawing/2014/main" id="{82A1EFE1-6E70-4399-ABD8-B91E1A69C8B4}"/>
                    </a:ext>
                  </a:extLst>
                </p:cNvPr>
                <p:cNvSpPr txBox="1"/>
                <p:nvPr/>
              </p:nvSpPr>
              <p:spPr>
                <a:xfrm rot="18900000">
                  <a:off x="79776" y="1561599"/>
                  <a:ext cx="325120" cy="24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C</a:t>
                  </a:r>
                  <a:endParaRPr lang="en-US" sz="1017" dirty="0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37">
                  <a:extLst>
                    <a:ext uri="{FF2B5EF4-FFF2-40B4-BE49-F238E27FC236}">
                      <a16:creationId xmlns:a16="http://schemas.microsoft.com/office/drawing/2014/main" id="{8AD60DFA-9CB7-4DD9-8375-61D835E70D38}"/>
                    </a:ext>
                  </a:extLst>
                </p:cNvPr>
                <p:cNvSpPr txBox="1"/>
                <p:nvPr/>
              </p:nvSpPr>
              <p:spPr>
                <a:xfrm rot="18900000">
                  <a:off x="350282" y="1556394"/>
                  <a:ext cx="478789" cy="24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Light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TextBox 38">
                  <a:extLst>
                    <a:ext uri="{FF2B5EF4-FFF2-40B4-BE49-F238E27FC236}">
                      <a16:creationId xmlns:a16="http://schemas.microsoft.com/office/drawing/2014/main" id="{D2ED7E56-2EE3-4F9C-B87E-C70BA94D0A53}"/>
                    </a:ext>
                  </a:extLst>
                </p:cNvPr>
                <p:cNvSpPr txBox="1"/>
                <p:nvPr/>
              </p:nvSpPr>
              <p:spPr>
                <a:xfrm rot="18900000">
                  <a:off x="698641" y="1556395"/>
                  <a:ext cx="464186" cy="2408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Blue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TextBox 39">
                  <a:extLst>
                    <a:ext uri="{FF2B5EF4-FFF2-40B4-BE49-F238E27FC236}">
                      <a16:creationId xmlns:a16="http://schemas.microsoft.com/office/drawing/2014/main" id="{0EC0B08D-38AD-4AD3-8E86-8C0763975380}"/>
                    </a:ext>
                  </a:extLst>
                </p:cNvPr>
                <p:cNvSpPr txBox="1"/>
                <p:nvPr/>
              </p:nvSpPr>
              <p:spPr>
                <a:xfrm rot="18900000">
                  <a:off x="1026601" y="1556395"/>
                  <a:ext cx="459105" cy="2408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latinLnBrk="1">
                    <a:lnSpc>
                      <a:spcPct val="107000"/>
                    </a:lnSpc>
                    <a:spcAft>
                      <a:spcPts val="740"/>
                    </a:spcAft>
                  </a:pPr>
                  <a:r>
                    <a:rPr lang="en-US" sz="831">
                      <a:solidFill>
                        <a:srgbClr val="000000"/>
                      </a:solidFill>
                      <a:latin typeface="Arial" panose="020B0604020202020204" pitchFamily="34" charset="0"/>
                      <a:ea typeface="Malgun Gothic" panose="020B0503020000020004" pitchFamily="34" charset="-127"/>
                      <a:cs typeface="Arial" panose="020B0604020202020204" pitchFamily="34" charset="0"/>
                    </a:rPr>
                    <a:t>Dark</a:t>
                  </a:r>
                  <a:endParaRPr lang="en-US" sz="1017">
                    <a:latin typeface="Calibri" panose="020F0502020204030204" pitchFamily="34" charset="0"/>
                    <a:ea typeface="Malgun Gothic" panose="020B0503020000020004" pitchFamily="34" charset="-127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0" name="직선 연결선 49">
                  <a:extLst>
                    <a:ext uri="{FF2B5EF4-FFF2-40B4-BE49-F238E27FC236}">
                      <a16:creationId xmlns:a16="http://schemas.microsoft.com/office/drawing/2014/main" id="{40141CA4-383F-4354-BB7D-072E452C205C}"/>
                    </a:ext>
                  </a:extLst>
                </p:cNvPr>
                <p:cNvCxnSpPr/>
                <p:nvPr/>
              </p:nvCxnSpPr>
              <p:spPr>
                <a:xfrm>
                  <a:off x="492596" y="1852076"/>
                  <a:ext cx="86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42" name="그림 7">
                  <a:extLst>
                    <a:ext uri="{FF2B5EF4-FFF2-40B4-BE49-F238E27FC236}">
                      <a16:creationId xmlns:a16="http://schemas.microsoft.com/office/drawing/2014/main" id="{E1996C65-9142-4173-849C-E09F56212C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79707"/>
                <a:stretch/>
              </p:blipFill>
              <p:spPr>
                <a:xfrm>
                  <a:off x="-198645" y="414969"/>
                  <a:ext cx="1738503" cy="1295024"/>
                </a:xfrm>
                <a:prstGeom prst="rect">
                  <a:avLst/>
                </a:prstGeom>
              </p:spPr>
            </p:pic>
          </p:grpSp>
        </p:grpSp>
        <p:sp>
          <p:nvSpPr>
            <p:cNvPr id="10" name="TextBox 19">
              <a:extLst>
                <a:ext uri="{FF2B5EF4-FFF2-40B4-BE49-F238E27FC236}">
                  <a16:creationId xmlns:a16="http://schemas.microsoft.com/office/drawing/2014/main" id="{EB6EBBAF-625B-4729-934D-5F12879BB910}"/>
                </a:ext>
              </a:extLst>
            </p:cNvPr>
            <p:cNvSpPr txBox="1"/>
            <p:nvPr/>
          </p:nvSpPr>
          <p:spPr>
            <a:xfrm rot="16200000">
              <a:off x="-407757" y="1327999"/>
              <a:ext cx="1200785" cy="256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1">
                <a:lnSpc>
                  <a:spcPct val="107000"/>
                </a:lnSpc>
                <a:spcAft>
                  <a:spcPts val="740"/>
                </a:spcAft>
              </a:pPr>
              <a:r>
                <a:rPr lang="en-US" sz="923" b="1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Cell viability (%)</a:t>
              </a:r>
              <a:endParaRPr lang="en-US" sz="1017"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19">
              <a:extLst>
                <a:ext uri="{FF2B5EF4-FFF2-40B4-BE49-F238E27FC236}">
                  <a16:creationId xmlns:a16="http://schemas.microsoft.com/office/drawing/2014/main" id="{FACF1089-28E7-402B-A9D4-DCC4EC007D6D}"/>
                </a:ext>
              </a:extLst>
            </p:cNvPr>
            <p:cNvSpPr txBox="1"/>
            <p:nvPr/>
          </p:nvSpPr>
          <p:spPr>
            <a:xfrm rot="16200000">
              <a:off x="-258129" y="3500439"/>
              <a:ext cx="1200785" cy="2563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latinLnBrk="1">
                <a:lnSpc>
                  <a:spcPct val="107000"/>
                </a:lnSpc>
                <a:spcAft>
                  <a:spcPts val="740"/>
                </a:spcAft>
              </a:pPr>
              <a:r>
                <a:rPr lang="en-US" sz="923" b="1" dirty="0">
                  <a:solidFill>
                    <a:srgbClr val="000000"/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Cell viability (%)</a:t>
              </a:r>
              <a:endParaRPr lang="en-US" sz="1017" dirty="0">
                <a:latin typeface="Calibri" panose="020F0502020204030204" pitchFamily="34" charset="0"/>
                <a:ea typeface="Malgun Gothic" panose="020B0503020000020004" pitchFamily="34" charset="-127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12540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1E9CD6D-78E0-48C7-9C2A-2ACE1CC127CE}"/>
              </a:ext>
            </a:extLst>
          </p:cNvPr>
          <p:cNvGrpSpPr/>
          <p:nvPr/>
        </p:nvGrpSpPr>
        <p:grpSpPr>
          <a:xfrm>
            <a:off x="873270" y="781108"/>
            <a:ext cx="5880942" cy="8248917"/>
            <a:chOff x="688946" y="828541"/>
            <a:chExt cx="5880942" cy="824891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051DB19-9C09-4A39-B63E-EE0DD7D89CB6}"/>
                </a:ext>
              </a:extLst>
            </p:cNvPr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763329" y="828541"/>
              <a:ext cx="1800468" cy="185359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B169C89-0770-450E-9374-42B974FBF217}"/>
                </a:ext>
              </a:extLst>
            </p:cNvPr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2563797" y="828541"/>
              <a:ext cx="1800468" cy="185359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0BA2001-A951-46D3-8562-BB9D9FFDA635}"/>
                </a:ext>
              </a:extLst>
            </p:cNvPr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4364265" y="828541"/>
              <a:ext cx="1800468" cy="185359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0A6211E-CA78-476C-98F8-62BE8526805F}"/>
                </a:ext>
              </a:extLst>
            </p:cNvPr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826100" y="2682138"/>
              <a:ext cx="2871894" cy="185359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D10FAB4-24E4-4CEF-A21D-FCF3EFD87424}"/>
                </a:ext>
              </a:extLst>
            </p:cNvPr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3697994" y="2663529"/>
              <a:ext cx="2871894" cy="185359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8BCA1AF-B6B9-4669-B762-4D5A301BA5CE}"/>
                </a:ext>
              </a:extLst>
            </p:cNvPr>
            <p:cNvPicPr/>
            <p:nvPr/>
          </p:nvPicPr>
          <p:blipFill>
            <a:blip r:embed="rId7"/>
            <a:stretch>
              <a:fillRect/>
            </a:stretch>
          </p:blipFill>
          <p:spPr>
            <a:xfrm>
              <a:off x="688946" y="4680572"/>
              <a:ext cx="2860088" cy="185359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02445D7-AD7C-470C-B7C7-BB7577D49EA8}"/>
                </a:ext>
              </a:extLst>
            </p:cNvPr>
            <p:cNvPicPr/>
            <p:nvPr/>
          </p:nvPicPr>
          <p:blipFill>
            <a:blip r:embed="rId8"/>
            <a:stretch>
              <a:fillRect/>
            </a:stretch>
          </p:blipFill>
          <p:spPr>
            <a:xfrm>
              <a:off x="3931959" y="4680572"/>
              <a:ext cx="2123175" cy="185359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7A0A888-C80B-4278-8B55-F2A8514FDCB3}"/>
                </a:ext>
              </a:extLst>
            </p:cNvPr>
            <p:cNvPicPr/>
            <p:nvPr/>
          </p:nvPicPr>
          <p:blipFill>
            <a:blip r:embed="rId9"/>
            <a:stretch>
              <a:fillRect/>
            </a:stretch>
          </p:blipFill>
          <p:spPr>
            <a:xfrm>
              <a:off x="763329" y="6679007"/>
              <a:ext cx="2123175" cy="218582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FD260856-B681-411C-B56C-BA48BC14AD0A}"/>
                </a:ext>
              </a:extLst>
            </p:cNvPr>
            <p:cNvPicPr/>
            <p:nvPr/>
          </p:nvPicPr>
          <p:blipFill>
            <a:blip r:embed="rId10"/>
            <a:stretch>
              <a:fillRect/>
            </a:stretch>
          </p:blipFill>
          <p:spPr>
            <a:xfrm>
              <a:off x="3549034" y="6697616"/>
              <a:ext cx="2311630" cy="2379842"/>
            </a:xfrm>
            <a:prstGeom prst="rect">
              <a:avLst/>
            </a:prstGeom>
          </p:spPr>
        </p:pic>
      </p:grpSp>
      <p:sp>
        <p:nvSpPr>
          <p:cNvPr id="12" name="Text Box 2">
            <a:extLst>
              <a:ext uri="{FF2B5EF4-FFF2-40B4-BE49-F238E27FC236}">
                <a16:creationId xmlns:a16="http://schemas.microsoft.com/office/drawing/2014/main" id="{92D9CDD9-4C9D-4130-A5E5-0BF60E5838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7523" y="676506"/>
            <a:ext cx="677128" cy="209205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vert="horz" wrap="square" lIns="84407" tIns="42203" rIns="84407" bIns="42203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740"/>
              </a:spcAft>
            </a:pPr>
            <a:r>
              <a:rPr lang="en-GB" sz="1108" b="1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Fig. S2</a:t>
            </a:r>
            <a:endParaRPr lang="en-US" sz="1017" dirty="0"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54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2</Words>
  <Application>Microsoft Office PowerPoint</Application>
  <PresentationFormat>On-screen Show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OrUdDiN SaDiQ</dc:creator>
  <cp:lastModifiedBy>Noor ud Din Bin Sadiq</cp:lastModifiedBy>
  <cp:revision>2</cp:revision>
  <dcterms:created xsi:type="dcterms:W3CDTF">2021-08-01T14:17:40Z</dcterms:created>
  <dcterms:modified xsi:type="dcterms:W3CDTF">2022-12-15T03:19:04Z</dcterms:modified>
</cp:coreProperties>
</file>